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2CE7BE-5FA4-48BF-9653-94BC1DBE8EB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9E6D05-9BB4-4FA0-812F-AFBC3AA82E9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8FB824-4DD9-4C27-8B40-AD680D534E0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29297A-0411-404F-9168-0C8AED84E86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7C3F4D-DDCE-4BCA-9313-238688816E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2300BF-4C88-4423-AAE1-CA91C559C8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058791-2FD5-4D77-B2FE-905A65B1F1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3C4ED1-20E4-4F51-906C-5A56F4BB11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3E57EA-7AD0-4CE9-BD55-4BED22E88F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9EB3A7-018D-4D3E-9C98-7D3A265E83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21C3E3-18E6-4A84-829B-3B20EAB824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A00D78-1D42-472F-B21C-FF8CE3E17E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32BB80A-74D3-423A-845A-450FB9C7EA5B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82A67B5-6176-4C08-A802-789BB165D48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"/>
          <p:cNvSpPr/>
          <p:nvPr/>
        </p:nvSpPr>
        <p:spPr>
          <a:xfrm>
            <a:off x="7290720" y="6284880"/>
            <a:ext cx="1678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dditional File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11"/>
          <p:cNvGrpSpPr/>
          <p:nvPr/>
        </p:nvGrpSpPr>
        <p:grpSpPr>
          <a:xfrm>
            <a:off x="1612800" y="428760"/>
            <a:ext cx="6078600" cy="5837760"/>
            <a:chOff x="1612800" y="428760"/>
            <a:chExt cx="6078600" cy="5837760"/>
          </a:xfrm>
        </p:grpSpPr>
        <p:pic>
          <p:nvPicPr>
            <p:cNvPr id="43" name="Picture 3" descr=""/>
            <p:cNvPicPr/>
            <p:nvPr/>
          </p:nvPicPr>
          <p:blipFill>
            <a:blip r:embed="rId1"/>
            <a:stretch/>
          </p:blipFill>
          <p:spPr>
            <a:xfrm>
              <a:off x="1612800" y="613440"/>
              <a:ext cx="5918400" cy="5479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Box 18"/>
            <p:cNvSpPr/>
            <p:nvPr/>
          </p:nvSpPr>
          <p:spPr>
            <a:xfrm>
              <a:off x="2401200" y="1388880"/>
              <a:ext cx="1095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ervous syste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TextBox 21"/>
            <p:cNvSpPr/>
            <p:nvPr/>
          </p:nvSpPr>
          <p:spPr>
            <a:xfrm>
              <a:off x="5814000" y="4667760"/>
              <a:ext cx="507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ive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TextBox 22"/>
            <p:cNvSpPr/>
            <p:nvPr/>
          </p:nvSpPr>
          <p:spPr>
            <a:xfrm>
              <a:off x="4809240" y="731520"/>
              <a:ext cx="1166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uscle + hear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Box 22"/>
            <p:cNvSpPr/>
            <p:nvPr/>
          </p:nvSpPr>
          <p:spPr>
            <a:xfrm>
              <a:off x="4310640" y="3165840"/>
              <a:ext cx="136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ell line + other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Oval 7"/>
            <p:cNvSpPr/>
            <p:nvPr/>
          </p:nvSpPr>
          <p:spPr>
            <a:xfrm>
              <a:off x="1728360" y="1282680"/>
              <a:ext cx="2354400" cy="2116080"/>
            </a:xfrm>
            <a:prstGeom prst="ellipse">
              <a:avLst/>
            </a:prstGeom>
            <a:noFill/>
            <a:ln w="12600">
              <a:solidFill>
                <a:srgbClr val="4a7ebb"/>
              </a:solidFill>
              <a:prstDash val="dot"/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Oval 8"/>
            <p:cNvSpPr/>
            <p:nvPr/>
          </p:nvSpPr>
          <p:spPr>
            <a:xfrm rot="1702200">
              <a:off x="5489640" y="2463480"/>
              <a:ext cx="1409760" cy="3689280"/>
            </a:xfrm>
            <a:prstGeom prst="ellipse">
              <a:avLst/>
            </a:prstGeom>
            <a:noFill/>
            <a:ln w="12600">
              <a:solidFill>
                <a:srgbClr val="4a7ebb"/>
              </a:solidFill>
              <a:prstDash val="dot"/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Oval 9"/>
            <p:cNvSpPr/>
            <p:nvPr/>
          </p:nvSpPr>
          <p:spPr>
            <a:xfrm rot="2545200">
              <a:off x="4765320" y="453600"/>
              <a:ext cx="858600" cy="2020680"/>
            </a:xfrm>
            <a:prstGeom prst="ellipse">
              <a:avLst/>
            </a:prstGeom>
            <a:noFill/>
            <a:ln w="12600">
              <a:solidFill>
                <a:srgbClr val="4a7ebb"/>
              </a:solidFill>
              <a:prstDash val="dot"/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1" name="Oval 10"/>
          <p:cNvSpPr/>
          <p:nvPr/>
        </p:nvSpPr>
        <p:spPr>
          <a:xfrm rot="19143600">
            <a:off x="4241880" y="1491840"/>
            <a:ext cx="3800520" cy="1689120"/>
          </a:xfrm>
          <a:prstGeom prst="ellipse">
            <a:avLst/>
          </a:prstGeom>
          <a:noFill/>
          <a:ln w="12600">
            <a:solidFill>
              <a:srgbClr val="4a7ebb"/>
            </a:solidFill>
            <a:prstDash val="dot"/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2"/>
          <p:cNvSpPr/>
          <p:nvPr/>
        </p:nvSpPr>
        <p:spPr>
          <a:xfrm>
            <a:off x="3763800" y="6039000"/>
            <a:ext cx="1355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Principal Component 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3"/>
          <p:cNvSpPr/>
          <p:nvPr/>
        </p:nvSpPr>
        <p:spPr>
          <a:xfrm rot="16200000">
            <a:off x="796320" y="3305880"/>
            <a:ext cx="1355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Principal Component 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03T13:34:55Z</dcterms:created>
  <dc:creator>Holly Bradley</dc:creator>
  <dc:description/>
  <dc:language>en-US</dc:language>
  <cp:lastModifiedBy>Holly Bradley</cp:lastModifiedBy>
  <dcterms:modified xsi:type="dcterms:W3CDTF">2010-12-03T13:36:17Z</dcterms:modified>
  <cp:revision>1</cp:revision>
  <dc:subject/>
  <dc:title>Slide 1</dc:title>
</cp:coreProperties>
</file>